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9"/>
  </p:notesMasterIdLst>
  <p:sldIdLst>
    <p:sldId id="256" r:id="rId2"/>
    <p:sldId id="271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2" r:id="rId1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2016"/>
    <p:restoredTop sz="94687"/>
  </p:normalViewPr>
  <p:slideViewPr>
    <p:cSldViewPr snapToGrid="0">
      <p:cViewPr varScale="1">
        <p:scale>
          <a:sx n="87" d="100"/>
          <a:sy n="87" d="100"/>
        </p:scale>
        <p:origin x="224" y="9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8640A08-1F8D-D341-B468-65460A5F971B}" type="datetimeFigureOut">
              <a:rPr lang="en-US" smtClean="0"/>
              <a:t>4/29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29A8D5-900C-C04A-975F-07FBDED8552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84193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Picture of person’s face with ptosis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029A8D5-900C-C04A-975F-07FBDED85525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8857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2BFABA-474D-4636-FA72-854A46893E1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F85123C-E815-6E4B-6CE2-D0691D06234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AF352F-B55B-1066-3886-61C4A4F264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CDFE-EDCA-014C-8236-6FADD9EF4EAE}" type="datetimeFigureOut">
              <a:rPr lang="en-US" smtClean="0"/>
              <a:t>4/29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3D98D3-BCE6-E40B-B184-A6BDCB380D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08C5BF-391D-FF03-37A8-C966CAF3A3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C4B55B-1AFC-2548-A144-EFC844E1C2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48939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5F08F2-6212-C385-542D-505A433862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F57FA9B-FDD9-87BF-8841-FB4377C7E33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1CAEEF-942B-E70E-BC88-541E31DBD9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CDFE-EDCA-014C-8236-6FADD9EF4EAE}" type="datetimeFigureOut">
              <a:rPr lang="en-US" smtClean="0"/>
              <a:t>4/29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133284-536A-F7F5-5B92-36B5587839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E3B2DE-4088-7522-F94D-E75DF4D274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C4B55B-1AFC-2548-A144-EFC844E1C2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89407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5A83636-9D11-AFBE-6DA9-15FAE5FF300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8556096-BBFF-CE2D-577B-995A6700E54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A40045-7E44-92D1-651E-94D2D58801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CDFE-EDCA-014C-8236-6FADD9EF4EAE}" type="datetimeFigureOut">
              <a:rPr lang="en-US" smtClean="0"/>
              <a:t>4/29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F6FA0E-9BAF-078C-290B-7D674465B4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795F84-DB91-CC0C-9680-9D794C6335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C4B55B-1AFC-2548-A144-EFC844E1C2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75498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12FAE5-BFFB-1202-F6D8-CD11CDFB6D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6B3C337-AED1-6596-4C83-74296494E72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F03AAA-819B-B09F-B707-0012E1116C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CDFE-EDCA-014C-8236-6FADD9EF4EAE}" type="datetimeFigureOut">
              <a:rPr lang="en-US" smtClean="0"/>
              <a:t>4/29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90386D8-9956-8B78-D469-F7FE86429A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865B10-DA31-28C6-D89F-1BE253480C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C4B55B-1AFC-2548-A144-EFC844E1C2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94921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4EB3C3-629A-F4BD-C863-DF617307C4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FEA68FE-AEC3-91E8-9432-401A1DBC7B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CF5716-D744-7B82-AD47-5EDBEBF8B6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CDFE-EDCA-014C-8236-6FADD9EF4EAE}" type="datetimeFigureOut">
              <a:rPr lang="en-US" smtClean="0"/>
              <a:t>4/29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D7900CD-2C78-3897-4C4D-B44A57FF5C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54A68D9-802E-6C39-C403-90CF7FE565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C4B55B-1AFC-2548-A144-EFC844E1C2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53028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964963-99FE-C755-9759-5ECAA31FB56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334719C-D234-CC2A-1454-93215EDAFDD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EFD5B76-D05D-9A40-0997-D6FB726D2B5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EC3EDE4-F879-B707-6904-96A7915EFF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CDFE-EDCA-014C-8236-6FADD9EF4EAE}" type="datetimeFigureOut">
              <a:rPr lang="en-US" smtClean="0"/>
              <a:t>4/29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7D76F3D-8E51-2E0E-2BBA-5269E2821E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6912A1D-A400-01F4-05AB-6CC4FAF9A9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C4B55B-1AFC-2548-A144-EFC844E1C2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0038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5961E9-1FB7-F057-E2DF-1F34421867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4505992-864E-7A95-4B84-0C1C095A02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E65B087-0BE6-F5EA-8CA5-64CBB8E178B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37D967E-F98A-C96B-2D5E-C2435DE19B9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25B6DD3-86AB-9AA0-83E1-45161B1122B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F5AD5C5-AFD2-D19E-DCE7-B54486790B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CDFE-EDCA-014C-8236-6FADD9EF4EAE}" type="datetimeFigureOut">
              <a:rPr lang="en-US" smtClean="0"/>
              <a:t>4/29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FF5C411-F8C5-397C-5451-0742E7B822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4969B83-1671-06BA-9A66-75A5E95C5F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C4B55B-1AFC-2548-A144-EFC844E1C2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38873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5B1B59-12AC-2D06-13AB-82038F446E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9B6FBC0-7C79-B050-C7B0-06E2B0F36A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CDFE-EDCA-014C-8236-6FADD9EF4EAE}" type="datetimeFigureOut">
              <a:rPr lang="en-US" smtClean="0"/>
              <a:t>4/29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407DAE9-7F1E-6E2D-A5FF-615C1EDBC2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0C79F00-5437-5FE1-9D07-5508BA9F38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C4B55B-1AFC-2548-A144-EFC844E1C2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8528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A01CF40-7C8C-BBBA-D044-32B0472CA7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CDFE-EDCA-014C-8236-6FADD9EF4EAE}" type="datetimeFigureOut">
              <a:rPr lang="en-US" smtClean="0"/>
              <a:t>4/29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E1F41E6-4F7E-1A23-2AD5-464887AD35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89EF0D7-8295-8590-1D62-44A2E3E0C7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C4B55B-1AFC-2548-A144-EFC844E1C2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63714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DB3E67-D318-6078-3649-A63319F8E3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98BDB55-1DCD-7CCC-56CE-C74CC00CDBA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A29CD3F-9DD9-C25B-2732-DD93A19B75A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485137-1CAD-F63C-A560-2A2787DDB1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CDFE-EDCA-014C-8236-6FADD9EF4EAE}" type="datetimeFigureOut">
              <a:rPr lang="en-US" smtClean="0"/>
              <a:t>4/29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18583E0-48A6-4D06-B2C4-07AC559A07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B4E8B22-4B7C-CCCB-A0E3-760310EC5A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C4B55B-1AFC-2548-A144-EFC844E1C2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14243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07FDA6-333C-C611-AA24-61C60F2700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6C08DF2-9270-9B1B-BAB0-EF17CA62599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6D5DD7B-7451-3816-E711-0D6067CBA18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F4282D8-DC87-C897-A837-B943654E41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42CDFE-EDCA-014C-8236-6FADD9EF4EAE}" type="datetimeFigureOut">
              <a:rPr lang="en-US" smtClean="0"/>
              <a:t>4/29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69EBEEF-DD84-0B48-9F62-A47FE4ED4C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8C7C0B0-3DAC-549C-98C0-E36C915617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C4B55B-1AFC-2548-A144-EFC844E1C2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09416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9DA6FC0-9BA5-99C0-107F-1C7189AE6D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18720DC-DF0A-3F93-27ED-DC803A5BB4C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68D2E9-065F-BB9E-FB22-E8015065730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42CDFE-EDCA-014C-8236-6FADD9EF4EAE}" type="datetimeFigureOut">
              <a:rPr lang="en-US" smtClean="0"/>
              <a:t>4/29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581A35-FEC3-F473-AAF2-813B1048FFA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6B3CD60-344F-04B0-E652-B1E1D2CF05C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C4B55B-1AFC-2548-A144-EFC844E1C23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45895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386747-8BE6-7133-A175-FA9D624E7E2F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Botulism due to Injection Drug Us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4F43092-5384-29E7-0423-55E2D58D0FC9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/>
              <a:t>Stimuli</a:t>
            </a:r>
          </a:p>
        </p:txBody>
      </p:sp>
    </p:spTree>
    <p:extLst>
      <p:ext uri="{BB962C8B-B14F-4D97-AF65-F5344CB8AC3E}">
        <p14:creationId xmlns:p14="http://schemas.microsoft.com/office/powerpoint/2010/main" val="8262085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0465356F-28DF-377B-AA30-98E4AA247239}"/>
              </a:ext>
            </a:extLst>
          </p:cNvPr>
          <p:cNvSpPr txBox="1"/>
          <p:nvPr/>
        </p:nvSpPr>
        <p:spPr>
          <a:xfrm>
            <a:off x="3049228" y="3105835"/>
            <a:ext cx="7481119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i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Thyroid stimulating hormone (TSH)	</a:t>
            </a: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3.64 </a:t>
            </a:r>
            <a:r>
              <a:rPr lang="en-US" sz="1800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ulU</a:t>
            </a: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/mL (0.550-4.780 </a:t>
            </a:r>
            <a:r>
              <a:rPr lang="en-US" sz="1800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ulU</a:t>
            </a: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/mL)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84367107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34FED745-CDBA-3F96-801E-827874D65633}"/>
              </a:ext>
            </a:extLst>
          </p:cNvPr>
          <p:cNvSpPr txBox="1"/>
          <p:nvPr/>
        </p:nvSpPr>
        <p:spPr>
          <a:xfrm>
            <a:off x="3049229" y="3105835"/>
            <a:ext cx="609845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i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Lactate		</a:t>
            </a: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1.5 mmol/L (&lt;1.0 mmol/L)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6877376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D814BDD3-21FC-8FAC-C69F-E80DB6A4396C}"/>
              </a:ext>
            </a:extLst>
          </p:cNvPr>
          <p:cNvSpPr txBox="1"/>
          <p:nvPr/>
        </p:nvSpPr>
        <p:spPr>
          <a:xfrm>
            <a:off x="3049229" y="3244334"/>
            <a:ext cx="609845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i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Troponin			</a:t>
            </a: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&lt;0.015 ml/mL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01060827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9025E49D-FBA0-A7FE-8D05-9E240ECB71FD}"/>
              </a:ext>
            </a:extLst>
          </p:cNvPr>
          <p:cNvSpPr txBox="1"/>
          <p:nvPr/>
        </p:nvSpPr>
        <p:spPr>
          <a:xfrm>
            <a:off x="3049229" y="2413338"/>
            <a:ext cx="6098458" cy="200054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i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Arterial Blood Gas (ABG)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it-IT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pH          			7.31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it-IT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pCO</a:t>
            </a:r>
            <a:r>
              <a:rPr lang="it-IT" sz="1800" b="1" baseline="-250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2</a:t>
            </a:r>
            <a:r>
              <a:rPr lang="it-IT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     			50 mmHg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it-IT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pO</a:t>
            </a:r>
            <a:r>
              <a:rPr lang="it-IT" sz="1800" b="1" baseline="-250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2</a:t>
            </a:r>
            <a:r>
              <a:rPr lang="it-IT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       			86 mmHg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it-IT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HCO</a:t>
            </a:r>
            <a:r>
              <a:rPr lang="it-IT" sz="1800" b="1" baseline="-250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3</a:t>
            </a:r>
            <a:r>
              <a:rPr lang="it-IT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     			23 </a:t>
            </a:r>
            <a:r>
              <a:rPr lang="it-IT" sz="1800" dirty="0" err="1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mEq</a:t>
            </a:r>
            <a:r>
              <a:rPr lang="it-IT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/L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O</a:t>
            </a:r>
            <a:r>
              <a:rPr lang="en-US" sz="1800" b="1" baseline="-250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2</a:t>
            </a: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 Saturation 		96% on room air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415629279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4EB306C5-35B8-08CA-17E4-8BAC706C031A}"/>
              </a:ext>
            </a:extLst>
          </p:cNvPr>
          <p:cNvSpPr txBox="1"/>
          <p:nvPr/>
        </p:nvSpPr>
        <p:spPr>
          <a:xfrm>
            <a:off x="3049229" y="3244334"/>
            <a:ext cx="609845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i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Ethanol level				</a:t>
            </a: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&lt;0.01 mg/dL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36157522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05CF8D8C-75D7-89B6-94D6-FD96EDC842B4}"/>
              </a:ext>
            </a:extLst>
          </p:cNvPr>
          <p:cNvSpPr txBox="1"/>
          <p:nvPr/>
        </p:nvSpPr>
        <p:spPr>
          <a:xfrm>
            <a:off x="3049229" y="1305342"/>
            <a:ext cx="6098458" cy="310854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i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Toxicology Screen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Amphetamines		Negative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Barbiturates		Negative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Benzodiazepines		Negative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Cocaine			Negative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Methadone		Negative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Opiates			Positive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Oxycodone		Negative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PCP			Negative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THC			Positive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997465772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264C3AF0-A3D0-E927-0EB0-1A9BB3F4D3AF}"/>
              </a:ext>
            </a:extLst>
          </p:cNvPr>
          <p:cNvSpPr txBox="1"/>
          <p:nvPr/>
        </p:nvSpPr>
        <p:spPr>
          <a:xfrm>
            <a:off x="3049229" y="1305342"/>
            <a:ext cx="6098458" cy="36625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i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Urinalysis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Leukocyte esterase		Negative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Nitrites			Negative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Blood			None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Protein			None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Ketones			1+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Glucose			None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Color			Dark Yellow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White blood cells		0-5 WBCs/HPF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Red blood cells		0-5 RBCs/HPF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Squamous epithelial cells	5-10 cells/HPF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Specific gravity		1.015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751311862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43F40DE2-16CD-77D5-BC62-4C1F7D5A64F4}"/>
              </a:ext>
            </a:extLst>
          </p:cNvPr>
          <p:cNvSpPr txBox="1"/>
          <p:nvPr/>
        </p:nvSpPr>
        <p:spPr>
          <a:xfrm>
            <a:off x="3049229" y="2136339"/>
            <a:ext cx="6098458" cy="227754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b="1" i="1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Cerebrospinal Fluid (CSF) studies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Appearance		Clear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Glucose			60 mg/dL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Protein			40 mg/dL 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White blood cells</a:t>
            </a: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		0-5 RBCs/</a:t>
            </a:r>
            <a:r>
              <a:rPr lang="en-US" sz="1800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uL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Red blood cells</a:t>
            </a: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		0-3 WBCs/</a:t>
            </a:r>
            <a:r>
              <a:rPr lang="en-US" sz="1800" dirty="0" err="1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uL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Gram stain		No organisms seen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9588886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collage of a child's face&#10;&#10;Description automatically generated with low confidence">
            <a:extLst>
              <a:ext uri="{FF2B5EF4-FFF2-40B4-BE49-F238E27FC236}">
                <a16:creationId xmlns:a16="http://schemas.microsoft.com/office/drawing/2014/main" id="{DA45BCE9-C468-7655-D79E-06873BD5DB74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76450" y="403172"/>
            <a:ext cx="8039100" cy="6051656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360738088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picture containing diagram, line, text&#10;&#10;Description automatically generated">
            <a:extLst>
              <a:ext uri="{FF2B5EF4-FFF2-40B4-BE49-F238E27FC236}">
                <a16:creationId xmlns:a16="http://schemas.microsoft.com/office/drawing/2014/main" id="{38388728-538F-E8C9-DA98-9AE761C67D9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621221"/>
            <a:ext cx="12141748" cy="5615558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40752297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x-ray of a person's chest&#10;&#10;Description automatically generated with medium confidence">
            <a:extLst>
              <a:ext uri="{FF2B5EF4-FFF2-40B4-BE49-F238E27FC236}">
                <a16:creationId xmlns:a16="http://schemas.microsoft.com/office/drawing/2014/main" id="{A0263022-C132-DA2A-64C3-AD305532E66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679" y="0"/>
            <a:ext cx="8460641" cy="685800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412326772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close-up of a brain scan&#10;&#10;Description automatically generated with low confidence">
            <a:extLst>
              <a:ext uri="{FF2B5EF4-FFF2-40B4-BE49-F238E27FC236}">
                <a16:creationId xmlns:a16="http://schemas.microsoft.com/office/drawing/2014/main" id="{C884E674-22CA-2E2C-CA8F-C91FE2F2E0E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79370" y="-87630"/>
            <a:ext cx="7033260" cy="7033260"/>
          </a:xfrm>
          <a:prstGeom prst="rect">
            <a:avLst/>
          </a:prstGeom>
          <a:noFill/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48589985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B22CF231-A67E-F7D9-C649-88E9516F0AFF}"/>
              </a:ext>
            </a:extLst>
          </p:cNvPr>
          <p:cNvSpPr txBox="1"/>
          <p:nvPr/>
        </p:nvSpPr>
        <p:spPr>
          <a:xfrm>
            <a:off x="3051810" y="2551837"/>
            <a:ext cx="6103620" cy="200054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1800" b="1" i="1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Complete blood count (CBC)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White blood count (WBC)		13.8 x 1000/mm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3	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Hemoglobin (Hgb)			13.8 g/dL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Hematocrit (HCT)			28.4%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Platelet (</a:t>
            </a:r>
            <a:r>
              <a:rPr lang="en-US" sz="1800" dirty="0" err="1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Plt</a:t>
            </a: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)				450 x 1000/mm</a:t>
            </a:r>
            <a:r>
              <a:rPr lang="en-US" sz="1800" baseline="300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3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Bands				17%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82633712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1DE1129A-5AF6-C665-B792-45117E7FC39C}"/>
              </a:ext>
            </a:extLst>
          </p:cNvPr>
          <p:cNvSpPr txBox="1"/>
          <p:nvPr/>
        </p:nvSpPr>
        <p:spPr>
          <a:xfrm>
            <a:off x="3049229" y="1997839"/>
            <a:ext cx="6098458" cy="28315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1800" b="1" i="1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Basic metabolic panel (BMP)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Sodium				143 </a:t>
            </a:r>
            <a:r>
              <a:rPr lang="en-US" sz="1800" dirty="0" err="1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mEq</a:t>
            </a: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/L 	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Potassium				4.1 </a:t>
            </a:r>
            <a:r>
              <a:rPr lang="en-US" sz="1800" dirty="0" err="1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mEq</a:t>
            </a: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/L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Chloride				98 </a:t>
            </a:r>
            <a:r>
              <a:rPr lang="en-US" sz="1800" dirty="0" err="1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mEq</a:t>
            </a: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/L 	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Bicarbonate (HCO</a:t>
            </a:r>
            <a:r>
              <a:rPr lang="en-US" sz="1800" baseline="-250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3</a:t>
            </a: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)			24 </a:t>
            </a:r>
            <a:r>
              <a:rPr lang="en-US" sz="1800" dirty="0" err="1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mEq</a:t>
            </a: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/L 	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Blood Urea Nitrogen (BUN)		35 mg/dL 	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Creatinine (Cr)				1.0 mg/dL 	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Glucose				88 mg/dL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Calcium				8.1 mg/dL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7122135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C1B540A7-4181-FB05-561E-EF4F966EFAC0}"/>
              </a:ext>
            </a:extLst>
          </p:cNvPr>
          <p:cNvSpPr txBox="1"/>
          <p:nvPr/>
        </p:nvSpPr>
        <p:spPr>
          <a:xfrm>
            <a:off x="3049229" y="2413338"/>
            <a:ext cx="6098458" cy="227754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r>
              <a:rPr lang="en-US" sz="1800" b="1" i="1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Liver function test (LFTs)</a:t>
            </a:r>
          </a:p>
          <a:p>
            <a:pPr marL="0" marR="0">
              <a:spcBef>
                <a:spcPts val="0"/>
              </a:spcBef>
              <a:spcAft>
                <a:spcPts val="0"/>
              </a:spcAft>
              <a:tabLst>
                <a:tab pos="1473200" algn="l"/>
              </a:tabLst>
            </a:pP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Total bilirubin			0.7 mg/dL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Direct bilirubin			0.3 mg/dL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Alkaline phosphatase		97 units/L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Aspartate aminotransferase (AST)	31 units/L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Alanine aminotransferase (ALT)	42 units/L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Albumin				2.7 g/dL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5440051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AF4D6DB1-8D16-0559-31B7-690E979CF2DC}"/>
              </a:ext>
            </a:extLst>
          </p:cNvPr>
          <p:cNvSpPr txBox="1"/>
          <p:nvPr/>
        </p:nvSpPr>
        <p:spPr>
          <a:xfrm>
            <a:off x="3049229" y="3105835"/>
            <a:ext cx="6098458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fontAlgn="base">
              <a:spcBef>
                <a:spcPts val="0"/>
              </a:spcBef>
              <a:spcAft>
                <a:spcPts val="0"/>
              </a:spcAft>
            </a:pPr>
            <a:r>
              <a:rPr lang="fr-FR" sz="1800" i="1" dirty="0" err="1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Magnesium</a:t>
            </a:r>
            <a:r>
              <a:rPr lang="fr-FR" sz="1800" i="1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	</a:t>
            </a:r>
            <a:r>
              <a:rPr lang="fr-FR" sz="1800" dirty="0">
                <a:effectLst/>
                <a:latin typeface="Calibri" panose="020F0502020204030204" pitchFamily="34" charset="0"/>
                <a:ea typeface="Arial Unicode MS" panose="020B0604020202020204" pitchFamily="34" charset="-128"/>
              </a:rPr>
              <a:t>	1.9 mEq/L</a:t>
            </a:r>
            <a:endParaRPr lang="en-US" sz="1600" dirty="0">
              <a:effectLst/>
              <a:latin typeface="Times New Roman" panose="02020603050405020304" pitchFamily="18" charset="0"/>
              <a:ea typeface="Arial Unicode MS" panose="020B060402020202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1061427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485</Words>
  <Application>Microsoft Macintosh PowerPoint</Application>
  <PresentationFormat>Widescreen</PresentationFormat>
  <Paragraphs>73</Paragraphs>
  <Slides>17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7</vt:i4>
      </vt:variant>
    </vt:vector>
  </HeadingPairs>
  <TitlesOfParts>
    <vt:vector size="22" baseType="lpstr">
      <vt:lpstr>Arial</vt:lpstr>
      <vt:lpstr>Calibri</vt:lpstr>
      <vt:lpstr>Calibri Light</vt:lpstr>
      <vt:lpstr>Times New Roman</vt:lpstr>
      <vt:lpstr>Office Theme</vt:lpstr>
      <vt:lpstr>Botulism due to Injection Drug Us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Botulism due to Injection Drug Use</dc:title>
  <dc:creator>Toohey, Shannon</dc:creator>
  <cp:lastModifiedBy>Toohey, Shannon</cp:lastModifiedBy>
  <cp:revision>3</cp:revision>
  <dcterms:created xsi:type="dcterms:W3CDTF">2023-04-29T18:28:29Z</dcterms:created>
  <dcterms:modified xsi:type="dcterms:W3CDTF">2023-04-29T18:33:44Z</dcterms:modified>
</cp:coreProperties>
</file>